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58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579" y="-2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478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297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033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817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531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592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36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767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931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785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237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DFE70-F659-45DA-9F37-37B80E867901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6C7D1-EBA6-4704-9697-A01510FCBA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23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1.png"/><Relationship Id="rId7" Type="http://schemas.openxmlformats.org/officeDocument/2006/relationships/image" Target="../media/image7.png"/><Relationship Id="rId12" Type="http://schemas.openxmlformats.org/officeDocument/2006/relationships/image" Target="../media/image10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tiff"/><Relationship Id="rId11" Type="http://schemas.openxmlformats.org/officeDocument/2006/relationships/image" Target="../media/image9.png"/><Relationship Id="rId5" Type="http://schemas.microsoft.com/office/2007/relationships/hdphoto" Target="../media/hdphoto2.wdp"/><Relationship Id="rId10" Type="http://schemas.microsoft.com/office/2007/relationships/hdphoto" Target="../media/hdphoto1.wdp"/><Relationship Id="rId4" Type="http://schemas.openxmlformats.org/officeDocument/2006/relationships/image" Target="../media/image5.png"/><Relationship Id="rId9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993866" y="4245541"/>
            <a:ext cx="46101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scopy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ype VI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brochaites</a:t>
            </a:r>
            <a:r>
              <a:rPr lang="de-DE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1777 </a:t>
            </a:r>
            <a:r>
              <a:rPr lang="de-DE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S. </a:t>
            </a:r>
            <a:r>
              <a:rPr lang="de-DE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copersicum</a:t>
            </a:r>
            <a:r>
              <a:rPr lang="de-DE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Va106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0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µm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1166590" y="1277018"/>
            <a:ext cx="2242707" cy="2280270"/>
            <a:chOff x="5206081" y="746213"/>
            <a:chExt cx="771163" cy="784079"/>
          </a:xfrm>
        </p:grpSpPr>
        <p:pic>
          <p:nvPicPr>
            <p:cNvPr id="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5" t="7498" r="7309" b="6185"/>
            <a:stretch/>
          </p:blipFill>
          <p:spPr bwMode="auto">
            <a:xfrm>
              <a:off x="5206081" y="746213"/>
              <a:ext cx="771163" cy="7840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9" name="Gerade Verbindung 38"/>
            <p:cNvCxnSpPr/>
            <p:nvPr/>
          </p:nvCxnSpPr>
          <p:spPr>
            <a:xfrm>
              <a:off x="5720624" y="1480349"/>
              <a:ext cx="2186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" name="Picture 7" descr="H:\Backcrosslines\Neuer Ordner\New folder\Neuer Ordner\WVA 106-f2.lsm-RGB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922" t="17971" r="21077" b="4408"/>
          <a:stretch/>
        </p:blipFill>
        <p:spPr bwMode="auto">
          <a:xfrm>
            <a:off x="3409297" y="1277018"/>
            <a:ext cx="2001946" cy="22851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779416" y="362280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LA1777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968482" y="3622803"/>
            <a:ext cx="10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WVa10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0537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407" y="1273810"/>
            <a:ext cx="5264785" cy="3319780"/>
          </a:xfrm>
          <a:prstGeom prst="rect">
            <a:avLst/>
          </a:prstGeom>
          <a:noFill/>
        </p:spPr>
      </p:pic>
      <p:sp>
        <p:nvSpPr>
          <p:cNvPr id="3" name="Textfeld 2"/>
          <p:cNvSpPr txBox="1"/>
          <p:nvPr/>
        </p:nvSpPr>
        <p:spPr>
          <a:xfrm>
            <a:off x="720407" y="5324475"/>
            <a:ext cx="593756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ample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ype VI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ap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eral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wild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mato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brochaite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60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µm.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A716: </a:t>
            </a:r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nellii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LA1306: </a:t>
            </a:r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mielewski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LA1346: </a:t>
            </a:r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canum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LA458: </a:t>
            </a:r>
            <a:r>
              <a:rPr lang="de-DE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lens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LA2096: S. </a:t>
            </a:r>
            <a:r>
              <a:rPr lang="de-DE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mpinellifolium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6926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/>
          <p:cNvSpPr txBox="1"/>
          <p:nvPr/>
        </p:nvSpPr>
        <p:spPr>
          <a:xfrm>
            <a:off x="2944681" y="1654395"/>
            <a:ext cx="756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-24</a:t>
            </a:r>
          </a:p>
        </p:txBody>
      </p:sp>
      <p:sp>
        <p:nvSpPr>
          <p:cNvPr id="6" name="TextBox 6"/>
          <p:cNvSpPr txBox="1"/>
          <p:nvPr/>
        </p:nvSpPr>
        <p:spPr>
          <a:xfrm>
            <a:off x="4298335" y="1654395"/>
            <a:ext cx="9181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-26</a:t>
            </a:r>
          </a:p>
        </p:txBody>
      </p:sp>
      <p:sp>
        <p:nvSpPr>
          <p:cNvPr id="7" name="TextBox 7"/>
          <p:cNvSpPr txBox="1"/>
          <p:nvPr/>
        </p:nvSpPr>
        <p:spPr>
          <a:xfrm>
            <a:off x="2245355" y="1654395"/>
            <a:ext cx="5933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5-1</a:t>
            </a:r>
          </a:p>
        </p:txBody>
      </p:sp>
      <p:sp>
        <p:nvSpPr>
          <p:cNvPr id="8" name="TextBox 8"/>
          <p:cNvSpPr txBox="1"/>
          <p:nvPr/>
        </p:nvSpPr>
        <p:spPr>
          <a:xfrm>
            <a:off x="3800470" y="1654395"/>
            <a:ext cx="5940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8-5</a:t>
            </a:r>
          </a:p>
        </p:txBody>
      </p:sp>
      <p:sp>
        <p:nvSpPr>
          <p:cNvPr id="9" name="TextBox 10"/>
          <p:cNvSpPr txBox="1"/>
          <p:nvPr/>
        </p:nvSpPr>
        <p:spPr>
          <a:xfrm>
            <a:off x="5260314" y="1654395"/>
            <a:ext cx="6288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A1777</a:t>
            </a:r>
          </a:p>
        </p:txBody>
      </p:sp>
      <p:sp>
        <p:nvSpPr>
          <p:cNvPr id="10" name="TextBox 11"/>
          <p:cNvSpPr txBox="1"/>
          <p:nvPr/>
        </p:nvSpPr>
        <p:spPr>
          <a:xfrm>
            <a:off x="774039" y="1654395"/>
            <a:ext cx="7109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Va10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456999" y="2552056"/>
            <a:ext cx="4375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schemeClr val="bg1"/>
                </a:solidFill>
              </a:rPr>
              <a:t>20 um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0" t="31672" r="17051" b="26911"/>
          <a:stretch/>
        </p:blipFill>
        <p:spPr>
          <a:xfrm>
            <a:off x="774039" y="2149089"/>
            <a:ext cx="5040560" cy="3672408"/>
          </a:xfrm>
          <a:prstGeom prst="rect">
            <a:avLst/>
          </a:prstGeom>
        </p:spPr>
      </p:pic>
      <p:sp>
        <p:nvSpPr>
          <p:cNvPr id="27" name="TextBox 11"/>
          <p:cNvSpPr txBox="1"/>
          <p:nvPr/>
        </p:nvSpPr>
        <p:spPr>
          <a:xfrm>
            <a:off x="1509697" y="1654395"/>
            <a:ext cx="7109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A402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798116" y="741182"/>
            <a:ext cx="5184040" cy="792088"/>
            <a:chOff x="0" y="956752"/>
            <a:chExt cx="6857999" cy="104785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5" t="7498" r="7309" b="6185"/>
            <a:stretch/>
          </p:blipFill>
          <p:spPr bwMode="auto">
            <a:xfrm>
              <a:off x="5831325" y="963408"/>
              <a:ext cx="1020176" cy="10372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 descr="F:\Backcrosslines\Neuer Ordner\New folder\Neuer Ordner\1-5d.lsm-RGB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81" t="2369" r="5404" b="8468"/>
            <a:stretch/>
          </p:blipFill>
          <p:spPr bwMode="auto">
            <a:xfrm>
              <a:off x="1847060" y="956753"/>
              <a:ext cx="1005876" cy="1043920"/>
            </a:xfrm>
            <a:prstGeom prst="rect">
              <a:avLst/>
            </a:prstGeom>
            <a:noFill/>
            <a:scene3d>
              <a:camera prst="orthographicFront">
                <a:rot lat="10800000" lon="0" rev="0"/>
              </a:camera>
              <a:lightRig rig="threePt" dir="t"/>
            </a:scene3d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9" name="Gerade Verbindung 38"/>
            <p:cNvCxnSpPr/>
            <p:nvPr/>
          </p:nvCxnSpPr>
          <p:spPr>
            <a:xfrm>
              <a:off x="6512017" y="1934601"/>
              <a:ext cx="289273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" name="Picture 5" descr="H:\Backcrosslines Stefan\8-5-7.lsm-RGB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34" t="19628" r="17286" b="14672"/>
            <a:stretch/>
          </p:blipFill>
          <p:spPr bwMode="auto">
            <a:xfrm>
              <a:off x="3808526" y="956752"/>
              <a:ext cx="1060634" cy="10372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39" t="24717" r="26158" b="22824"/>
            <a:stretch/>
          </p:blipFill>
          <p:spPr bwMode="auto">
            <a:xfrm>
              <a:off x="4809219" y="963408"/>
              <a:ext cx="1022965" cy="10372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44" t="72035" r="26158" b="22824"/>
            <a:stretch/>
          </p:blipFill>
          <p:spPr bwMode="auto">
            <a:xfrm>
              <a:off x="4757726" y="1827470"/>
              <a:ext cx="225114" cy="1732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44" t="72035" r="26158" b="22824"/>
            <a:stretch/>
          </p:blipFill>
          <p:spPr bwMode="auto">
            <a:xfrm>
              <a:off x="5658072" y="959242"/>
              <a:ext cx="225114" cy="1732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 descr="H:\Backcrosslines\Neuer Ordner\New folder\Neuer Ordner\WVA 106-f2.lsm-RGB.tif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22" t="17971" r="21077" b="4408"/>
            <a:stretch/>
          </p:blipFill>
          <p:spPr bwMode="auto">
            <a:xfrm>
              <a:off x="0" y="967347"/>
              <a:ext cx="908720" cy="10372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Rechteck 21"/>
            <p:cNvSpPr/>
            <p:nvPr/>
          </p:nvSpPr>
          <p:spPr>
            <a:xfrm>
              <a:off x="0" y="959243"/>
              <a:ext cx="6857999" cy="10347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350"/>
            </a:p>
          </p:txBody>
        </p:sp>
        <p:pic>
          <p:nvPicPr>
            <p:cNvPr id="13" name="Picture 6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08" t="25430" r="24309" b="22754"/>
            <a:stretch/>
          </p:blipFill>
          <p:spPr bwMode="auto">
            <a:xfrm>
              <a:off x="836306" y="967347"/>
              <a:ext cx="1080526" cy="1033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7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53" t="18050" r="12829" b="12439"/>
            <a:stretch/>
          </p:blipFill>
          <p:spPr bwMode="auto">
            <a:xfrm>
              <a:off x="2854064" y="956752"/>
              <a:ext cx="1078992" cy="10427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4" name="Textfeld 23"/>
          <p:cNvSpPr txBox="1"/>
          <p:nvPr/>
        </p:nvSpPr>
        <p:spPr>
          <a:xfrm>
            <a:off x="798116" y="6200775"/>
            <a:ext cx="5179128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.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core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cellular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orag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ype VI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k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 laser-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nning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scop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at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z-position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rges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0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µm.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s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ulat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core 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1)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k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ep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Wva106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k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total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chom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ott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-fitt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Sigma Plot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10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s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fit was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tain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gre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nomial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quatio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p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 r²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0.93. The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sh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tted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The solid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 99%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fidenc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7968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770" y="1256982"/>
            <a:ext cx="5458460" cy="6534785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33450" y="7471886"/>
            <a:ext cx="493395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.</a:t>
            </a:r>
            <a:r>
              <a:rPr lang="en-US" sz="11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kage Map with the relative (on the left; in </a:t>
            </a:r>
            <a:r>
              <a:rPr lang="en-US" sz="1100" b="1" dirty="0" err="1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M</a:t>
            </a:r>
            <a:r>
              <a:rPr lang="en-US" sz="11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absolute (on the right; in MB) positioning of the markers.</a:t>
            </a:r>
            <a:endParaRPr lang="en-US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6265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3</Words>
  <Application>Microsoft Office PowerPoint</Application>
  <PresentationFormat>A4-Papier (210x297 mm)</PresentationFormat>
  <Paragraphs>14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IP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ssier, Alain</dc:creator>
  <cp:lastModifiedBy>Tissier, Alain</cp:lastModifiedBy>
  <cp:revision>7</cp:revision>
  <dcterms:created xsi:type="dcterms:W3CDTF">2018-04-12T11:38:01Z</dcterms:created>
  <dcterms:modified xsi:type="dcterms:W3CDTF">2018-09-17T15:46:38Z</dcterms:modified>
</cp:coreProperties>
</file>